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14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5"/>
    <p:restoredTop sz="94649"/>
  </p:normalViewPr>
  <p:slideViewPr>
    <p:cSldViewPr snapToGrid="0" snapToObjects="1">
      <p:cViewPr varScale="1">
        <p:scale>
          <a:sx n="145" d="100"/>
          <a:sy n="145" d="100"/>
        </p:scale>
        <p:origin x="18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49B670-CB17-5743-A445-DB3EA60C3890}" type="datetimeFigureOut">
              <a:rPr lang="en-US" smtClean="0"/>
              <a:t>8/2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C08348-19A2-EA49-853B-76FCB35BCB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404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Google Shape;188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89" name="Google Shape;189;p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42441985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498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016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4196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220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909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971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838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4959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485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106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135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19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5DA76A5-2A9E-4D43-9B74-D001F4D90B1A}"/>
              </a:ext>
            </a:extLst>
          </p:cNvPr>
          <p:cNvSpPr txBox="1"/>
          <p:nvPr/>
        </p:nvSpPr>
        <p:spPr>
          <a:xfrm>
            <a:off x="3284543" y="2567198"/>
            <a:ext cx="184731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05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FD2C120-BCCF-D44F-A2D5-CCFC8F120DDD}"/>
              </a:ext>
            </a:extLst>
          </p:cNvPr>
          <p:cNvSpPr txBox="1"/>
          <p:nvPr/>
        </p:nvSpPr>
        <p:spPr>
          <a:xfrm>
            <a:off x="6970295" y="6925176"/>
            <a:ext cx="184731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401"/>
          </a:p>
        </p:txBody>
      </p:sp>
      <p:sp>
        <p:nvSpPr>
          <p:cNvPr id="7" name="Google Shape;65;p2">
            <a:extLst>
              <a:ext uri="{FF2B5EF4-FFF2-40B4-BE49-F238E27FC236}">
                <a16:creationId xmlns:a16="http://schemas.microsoft.com/office/drawing/2014/main" id="{79BBF39E-122E-73E4-A261-86CB828B82DF}"/>
              </a:ext>
            </a:extLst>
          </p:cNvPr>
          <p:cNvSpPr txBox="1"/>
          <p:nvPr/>
        </p:nvSpPr>
        <p:spPr>
          <a:xfrm>
            <a:off x="169101" y="2965780"/>
            <a:ext cx="358800" cy="4002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6" tIns="91426" rIns="91426" bIns="91426" anchor="t" anchorCtr="0">
            <a:spAutoFit/>
          </a:bodyPr>
          <a:lstStyle/>
          <a:p>
            <a:pPr>
              <a:buSzPts val="1400"/>
            </a:pPr>
            <a:r>
              <a:rPr lang="en-US" sz="1401" b="1" dirty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  <a:endParaRPr sz="1401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" name="Google Shape;64;p2">
            <a:extLst>
              <a:ext uri="{FF2B5EF4-FFF2-40B4-BE49-F238E27FC236}">
                <a16:creationId xmlns:a16="http://schemas.microsoft.com/office/drawing/2014/main" id="{9A3B5FD8-92AD-5054-045F-528746911375}"/>
              </a:ext>
            </a:extLst>
          </p:cNvPr>
          <p:cNvSpPr txBox="1"/>
          <p:nvPr/>
        </p:nvSpPr>
        <p:spPr>
          <a:xfrm>
            <a:off x="169101" y="147367"/>
            <a:ext cx="358800" cy="4002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6" tIns="91426" rIns="91426" bIns="91426" anchor="t" anchorCtr="0">
            <a:spAutoFit/>
          </a:bodyPr>
          <a:lstStyle/>
          <a:p>
            <a:pPr>
              <a:buSzPts val="1400"/>
            </a:pPr>
            <a:r>
              <a:rPr lang="en-US" sz="1401" b="1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  <a:endParaRPr sz="1401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0B0A884B-1F5B-4CEF-756A-3C778BC86B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1395" y="183277"/>
            <a:ext cx="3410341" cy="242834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483B52E-392D-9EDA-65AF-83A6B5D2C88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93554" y="137618"/>
            <a:ext cx="3066438" cy="262517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D75A81E6-8E38-C071-6517-128A0DEE963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5237" y="2929814"/>
            <a:ext cx="3541145" cy="2737999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CC8767D5-F7B3-D8FB-B249-4822013F702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61736" y="2965780"/>
            <a:ext cx="3100879" cy="2664818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94406610-F2B3-4445-A49B-6AEB59A463F4}"/>
              </a:ext>
            </a:extLst>
          </p:cNvPr>
          <p:cNvSpPr/>
          <p:nvPr/>
        </p:nvSpPr>
        <p:spPr>
          <a:xfrm>
            <a:off x="269266" y="6089722"/>
            <a:ext cx="6400015" cy="16709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000" b="1" dirty="0">
                <a:latin typeface="TimesNewRomanPS"/>
                <a:ea typeface="Times New Roman" panose="02020603050405020304" pitchFamily="18" charset="0"/>
              </a:rPr>
              <a:t>Supplementary Figure 5. Piperacetazine is not effective in preventing PAX3::FOXO1- mediated tumorigenesis at the tested dose. </a:t>
            </a:r>
            <a:r>
              <a:rPr lang="en-US" sz="1000" dirty="0">
                <a:latin typeface="TimesNewRomanPSMT" panose="02020603050405020304" pitchFamily="18" charset="0"/>
                <a:ea typeface="Times New Roman" panose="02020603050405020304" pitchFamily="18" charset="0"/>
              </a:rPr>
              <a:t>(</a:t>
            </a:r>
            <a:r>
              <a:rPr lang="en-US" sz="1000" b="1" dirty="0">
                <a:latin typeface="TimesNewRomanPS"/>
                <a:ea typeface="Times New Roman" panose="02020603050405020304" pitchFamily="18" charset="0"/>
              </a:rPr>
              <a:t>A</a:t>
            </a:r>
            <a:r>
              <a:rPr lang="en-US" sz="1000" dirty="0">
                <a:latin typeface="TimesNewRomanPSMT" panose="02020603050405020304" pitchFamily="18" charset="0"/>
                <a:ea typeface="Times New Roman" panose="02020603050405020304" pitchFamily="18" charset="0"/>
              </a:rPr>
              <a:t>) Left: Xenograft model using RH30 cells in mice. Piperacetazine was administered IP at 20 mg/kg/day 5 days/week (horizontal red line). Two-tailed Mann Whitney test comparing AUC of each treatment calculated a p-value of 0.0683. Error bars show SEM. Right: Animal weights during study. (</a:t>
            </a:r>
            <a:r>
              <a:rPr lang="en-US" sz="1000" b="1" dirty="0">
                <a:latin typeface="TimesNewRomanPS"/>
                <a:ea typeface="Times New Roman" panose="02020603050405020304" pitchFamily="18" charset="0"/>
              </a:rPr>
              <a:t>B</a:t>
            </a:r>
            <a:r>
              <a:rPr lang="en-US" sz="1000" dirty="0">
                <a:latin typeface="TimesNewRomanPSMT" panose="02020603050405020304" pitchFamily="18" charset="0"/>
                <a:ea typeface="Times New Roman" panose="02020603050405020304" pitchFamily="18" charset="0"/>
              </a:rPr>
              <a:t>) Left: Xenograft model using </a:t>
            </a:r>
            <a:r>
              <a:rPr lang="en-US" sz="1000" dirty="0" err="1">
                <a:latin typeface="TimesNewRomanPSMT" panose="02020603050405020304" pitchFamily="18" charset="0"/>
                <a:ea typeface="Times New Roman" panose="02020603050405020304" pitchFamily="18" charset="0"/>
              </a:rPr>
              <a:t>Dbt</a:t>
            </a:r>
            <a:r>
              <a:rPr lang="en-US" sz="1000" dirty="0">
                <a:latin typeface="TimesNewRomanPSMT" panose="02020603050405020304" pitchFamily="18" charset="0"/>
                <a:ea typeface="Times New Roman" panose="02020603050405020304" pitchFamily="18" charset="0"/>
              </a:rPr>
              <a:t>-MYCN/indP3F cells in mice. All animals began the study on a 625 mg/kg doxycycline diet to induce the expression of PAX3::FOXO1. Doxycycline-containing feed was removed from the positive control group (black line) on day 8. The same day that treatments began for 20 mg/kg/day piperacetazine (blue line) and vehicle (gray line) groups, while they continued to receive a 625 mg/kg doxycycline diet. Error bars show SEM. Right: Animal weights during study. </a:t>
            </a:r>
            <a:endParaRPr lang="en-US" sz="10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30956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87</Words>
  <Application>Microsoft Macintosh PowerPoint</Application>
  <PresentationFormat>Letter Paper (8.5x11 in)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</vt:lpstr>
      <vt:lpstr>Calibri</vt:lpstr>
      <vt:lpstr>Calibri Light</vt:lpstr>
      <vt:lpstr>Helvetica</vt:lpstr>
      <vt:lpstr>Times New Roman</vt:lpstr>
      <vt:lpstr>TimesNewRomanPS</vt:lpstr>
      <vt:lpstr>TimesNewRomanPSM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4</cp:revision>
  <dcterms:created xsi:type="dcterms:W3CDTF">2023-07-14T20:06:09Z</dcterms:created>
  <dcterms:modified xsi:type="dcterms:W3CDTF">2023-08-23T15:05:55Z</dcterms:modified>
</cp:coreProperties>
</file>